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581400" cy="59832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F6196-B4DF-4B11-8D0E-1ACFA65EAE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30448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68200" y="3602160"/>
            <a:ext cx="30448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9DD2E-E1B0-4997-83D2-D1EB034BC7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82844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68200" y="360216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828440" y="360216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FAFAA-9FBF-4F02-8000-B535A546B4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297800" y="172728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327400" y="172728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68200" y="360216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297800" y="360216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327400" y="3602160"/>
            <a:ext cx="9802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346A8-46B2-4393-9011-A355892B07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68200" y="1727280"/>
            <a:ext cx="3044880" cy="358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F7015C-8B0C-4A95-8435-94BD802170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304488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41E41-F496-4147-92DC-574808514F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148572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828440" y="1727280"/>
            <a:ext cx="148572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7F043-8517-4CB7-BF51-0E6A93945C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DC773-00C1-4905-ADE5-DDEB01FDB4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68200" y="529920"/>
            <a:ext cx="3044880" cy="4622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02F46-C176-4F12-8AB4-70DAF8D69F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828440" y="1727280"/>
            <a:ext cx="148572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68200" y="360216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442FF-4CDA-4145-A895-DD37D22363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148572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82844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828440" y="360216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35942-B5A4-4840-B671-EADC0A3E50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6820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828440" y="1727280"/>
            <a:ext cx="148572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68200" y="3602160"/>
            <a:ext cx="3044880" cy="17118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57429-1E5F-4815-9342-C3D3C42B1C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68200" y="529920"/>
            <a:ext cx="3044880" cy="99684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68200" y="1727280"/>
            <a:ext cx="3044880" cy="358920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 fontScale="92000"/>
          </a:bodyPr>
          <a:p>
            <a:pPr marL="198720" indent="-198720">
              <a:spcBef>
                <a:spcPts val="499"/>
              </a:spcBef>
              <a:buClr>
                <a:srgbClr val="000000"/>
              </a:buClr>
              <a:buFont typeface="Times New Roman"/>
              <a:buChar char="•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1" marL="429120" indent="-164880">
              <a:spcBef>
                <a:spcPts val="499"/>
              </a:spcBef>
              <a:buClr>
                <a:srgbClr val="000000"/>
              </a:buClr>
              <a:buFont typeface="Times New Roman"/>
              <a:buChar char="–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2" marL="661680" indent="-132840">
              <a:spcBef>
                <a:spcPts val="499"/>
              </a:spcBef>
              <a:buClr>
                <a:srgbClr val="000000"/>
              </a:buClr>
              <a:buFont typeface="Times New Roman"/>
              <a:buChar char="•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3" marL="925920" indent="-132840">
              <a:spcBef>
                <a:spcPts val="499"/>
              </a:spcBef>
              <a:buClr>
                <a:srgbClr val="000000"/>
              </a:buClr>
              <a:buFont typeface="Times New Roman"/>
              <a:buChar char="–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4" marL="1190160" indent="-132480">
              <a:spcBef>
                <a:spcPts val="499"/>
              </a:spcBef>
              <a:buClr>
                <a:srgbClr val="000000"/>
              </a:buClr>
              <a:buFont typeface="Times New Roman"/>
              <a:buChar char="»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5" marL="1190160" indent="-132480">
              <a:spcBef>
                <a:spcPts val="499"/>
              </a:spcBef>
              <a:buClr>
                <a:srgbClr val="000000"/>
              </a:buClr>
              <a:buFont typeface="Times New Roman"/>
              <a:buChar char="»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lvl="6" marL="1190160" indent="-132480">
              <a:spcBef>
                <a:spcPts val="499"/>
              </a:spcBef>
              <a:buClr>
                <a:srgbClr val="000000"/>
              </a:buClr>
              <a:buFont typeface="Times New Roman"/>
              <a:buChar char="»"/>
              <a:tabLst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7840" y="5451480"/>
            <a:ext cx="746280" cy="3967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lstStyle>
            <a:lvl1pPr indent="0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  <a:defRPr b="0" lang="en-US" sz="9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224000" y="5451480"/>
            <a:ext cx="1133280" cy="3967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lstStyle>
            <a:lvl1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  <a:defRPr b="0" lang="en-US" sz="9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567160" y="5451480"/>
            <a:ext cx="745920" cy="3967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lstStyle>
            <a:lvl1pPr indent="0" algn="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  <a:defRPr b="0" lang="en-US" sz="9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574560"/>
                <a:tab algn="l" pos="1149480"/>
                <a:tab algn="l" pos="1724040"/>
                <a:tab algn="l" pos="2298600"/>
                <a:tab algn="l" pos="2873520"/>
                <a:tab algn="l" pos="3448080"/>
                <a:tab algn="l" pos="4022640"/>
                <a:tab algn="l" pos="4597560"/>
                <a:tab algn="l" pos="5172120"/>
                <a:tab algn="l" pos="5746680"/>
                <a:tab algn="l" pos="6321600"/>
                <a:tab algn="l" pos="6896160"/>
                <a:tab algn="l" pos="7470720"/>
                <a:tab algn="l" pos="8045280"/>
                <a:tab algn="l" pos="8620200"/>
                <a:tab algn="l" pos="9194760"/>
                <a:tab algn="l" pos="9769320"/>
                <a:tab algn="l" pos="10344240"/>
                <a:tab algn="l" pos="10918800"/>
              </a:tabLst>
            </a:pPr>
            <a:fld id="{8F480EC5-A009-4D4D-896B-96212922A5AB}" type="slidenum"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8480" y="30240"/>
            <a:ext cx="3416760" cy="5838840"/>
            <a:chOff x="78480" y="30240"/>
            <a:chExt cx="3416760" cy="58388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298520" y="377640"/>
              <a:ext cx="1050840" cy="93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2475000" y="69012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470320" y="86004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82920" y="97776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881800" y="453600"/>
              <a:ext cx="613440" cy="33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r>
                <a:rPr b="0" lang="fr-FR" sz="1400" spc="-1" strike="noStrike" baseline="-25000">
                  <a:solidFill>
                    <a:srgbClr val="000000"/>
                  </a:solidFill>
                  <a:latin typeface="Arial"/>
                </a:rPr>
                <a:t>EL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855520" y="676080"/>
              <a:ext cx="545040" cy="33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r>
                <a:rPr b="0" lang="fr-FR" sz="1400" spc="-1" strike="noStrike" baseline="-25000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859840" y="909360"/>
              <a:ext cx="555840" cy="33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r>
                <a:rPr b="0" lang="fr-FR" sz="1400" spc="-1" strike="noStrike" baseline="-25000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849960" y="66240"/>
              <a:ext cx="1535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RT        -           +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13560" y="5592600"/>
              <a:ext cx="310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Overexpressing</a:t>
              </a: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 Bim S or L kills motoneuron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51" name=""/>
            <p:cNvGraphicFramePr/>
            <p:nvPr/>
          </p:nvGraphicFramePr>
          <p:xfrm>
            <a:off x="1285920" y="2063520"/>
            <a:ext cx="1700280" cy="282852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52" name="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1285920" y="2063520"/>
                      <a:ext cx="1700280" cy="2828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3" name=""/>
            <p:cNvSpPr/>
            <p:nvPr/>
          </p:nvSpPr>
          <p:spPr>
            <a:xfrm>
              <a:off x="878400" y="2033280"/>
              <a:ext cx="47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873720" y="2477880"/>
              <a:ext cx="47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33120" y="288756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82800" y="4655880"/>
              <a:ext cx="614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28080" y="330156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33120" y="373032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933120" y="416700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6200000">
              <a:off x="-460440" y="3326400"/>
              <a:ext cx="224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% motoneuron survival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6200000">
              <a:off x="1806480" y="4902840"/>
              <a:ext cx="609120" cy="37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r>
                <a:rPr b="0" lang="fr-FR" sz="1600" spc="-1" strike="noStrike" baseline="-25000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6200000">
              <a:off x="2190600" y="4901040"/>
              <a:ext cx="596880" cy="37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Bim</a:t>
              </a:r>
              <a:r>
                <a:rPr b="0" lang="fr-FR" sz="1600" spc="-1" strike="noStrike" baseline="-25000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8480" y="30240"/>
              <a:ext cx="400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03320" y="1858680"/>
              <a:ext cx="3834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76360" y="1477800"/>
              <a:ext cx="2579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Times New Roman"/>
                </a:rPr>
                <a:t>Bim 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is</a:t>
              </a:r>
              <a:r>
                <a:rPr b="0" lang="fr-FR" sz="1400" spc="-1" strike="noStrike">
                  <a:solidFill>
                    <a:srgbClr val="000000"/>
                  </a:solidFill>
                  <a:latin typeface="Times New Roman"/>
                </a:rPr>
                <a:t> expressed in motoneuron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1-23T12:56:07Z</dcterms:created>
  <dc:creator>pettmann</dc:creator>
  <dc:description/>
  <dc:language>en-US</dc:language>
  <cp:lastModifiedBy>pettmann</cp:lastModifiedBy>
  <dcterms:modified xsi:type="dcterms:W3CDTF">2004-11-23T12:56:38Z</dcterms:modified>
  <cp:revision>1</cp:revision>
  <dc:subject/>
  <dc:title>Présentation PowerPoint</dc:title>
</cp:coreProperties>
</file>